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22044" y="1345439"/>
            <a:ext cx="68058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Ultrasound embryo measurements at 7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in first generation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" name="Tableau 7"/>
          <p:cNvGraphicFramePr>
            <a:graphicFrameLocks noGrp="1"/>
          </p:cNvGraphicFramePr>
          <p:nvPr/>
        </p:nvGraphicFramePr>
        <p:xfrm>
          <a:off x="94952" y="1628800"/>
          <a:ext cx="6660000" cy="1109664"/>
        </p:xfrm>
        <a:graphic>
          <a:graphicData uri="http://schemas.openxmlformats.org/drawingml/2006/table">
            <a:tbl>
              <a:tblPr/>
              <a:tblGrid>
                <a:gridCol w="1117149"/>
                <a:gridCol w="319186"/>
                <a:gridCol w="319186"/>
                <a:gridCol w="1196948"/>
                <a:gridCol w="1313633"/>
                <a:gridCol w="718169"/>
                <a:gridCol w="1037355"/>
                <a:gridCol w="638374"/>
              </a:tblGrid>
              <a:tr h="28575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riable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umber</a:t>
                      </a:r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of </a:t>
                      </a:r>
                      <a:r>
                        <a:rPr lang="fr-FR" sz="1000" b="1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mbryos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dian</a:t>
                      </a:r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Q1;</a:t>
                      </a:r>
                      <a:r>
                        <a:rPr lang="fr-FR" sz="1000" b="1" i="0" u="none" strike="noStrike" baseline="0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Q3]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am - </a:t>
                      </a:r>
                      <a:r>
                        <a:rPr lang="fr-FR" sz="1000" b="1" i="0" u="none" strike="noStrike" dirty="0" err="1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justed</a:t>
                      </a:r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1" i="0" u="none" strike="noStrike" dirty="0" err="1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near</a:t>
                      </a:r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model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287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β </a:t>
                      </a:r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lue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I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-value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87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meter</a:t>
                      </a:r>
                      <a:r>
                        <a:rPr lang="fr-FR" sz="1000" b="0" i="0" u="none" strike="noStrike" baseline="0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1 (mm)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3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4 [5.4; 7.1]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1 [5.1; 6.9]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384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.144;0.376]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28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287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ameter</a:t>
                      </a:r>
                      <a:r>
                        <a:rPr lang="fr-FR" sz="1000" b="0" i="0" u="none" strike="noStrike" baseline="0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 (mm)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3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3 [4.6; 6.4]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2 [4.2; 6.0]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0.404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1.251;0.443]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55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87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err="1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rimeter</a:t>
                      </a:r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(mm)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3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5 [16.23; 20.15]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.2 [14.70; 20.00]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.35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3.791;1.09]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5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87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olume (mm</a:t>
                      </a:r>
                      <a:r>
                        <a:rPr lang="fr-FR" sz="1000" b="0" i="0" u="none" strike="noStrike" baseline="30000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9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3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2.3 [69.42; 137.2]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8.51 [52.32; 129.7]</a:t>
                      </a:r>
                      <a:endParaRPr lang="fr-FR" sz="1000" b="0" i="0" u="none" strike="noStrike" dirty="0">
                        <a:solidFill>
                          <a:sysClr val="windowText" lastClr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16.652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-56.916;23.613]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ysClr val="windowText" lastClr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422</a:t>
                      </a:r>
                    </a:p>
                  </a:txBody>
                  <a:tcPr marL="12700" marR="12700" marT="714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94952" y="2744352"/>
            <a:ext cx="6660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llipse was used to measure embryo diameters. Diameter 1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epresents the longest one and Diameter 2 the shortest one. All data are expressed as median [Q1;Q3].</a:t>
            </a:r>
            <a:endParaRPr lang="fr-FR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1</TotalTime>
  <Words>164</Words>
  <Application>Microsoft Office PowerPoint</Application>
  <PresentationFormat>Affichage à l'écran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59</cp:revision>
  <dcterms:created xsi:type="dcterms:W3CDTF">2015-02-24T15:36:47Z</dcterms:created>
  <dcterms:modified xsi:type="dcterms:W3CDTF">2016-02-08T10:29:04Z</dcterms:modified>
</cp:coreProperties>
</file>